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82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79C66E-E407-4426-98FC-13FE5CD8FD8D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1B68FE-A1FC-4E21-8906-9258681C49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2639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1B68FE-A1FC-4E21-8906-9258681C49DB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5135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93D716-3974-AB23-A037-F8AA4E40A4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467D2C88-EC50-CE0C-32E7-C47E4251B6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9E40477-4C34-55D5-AF61-24C37257B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542EF17-D496-9421-FDD7-72681C770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12BABA-6264-EC33-6478-CFE616E62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0861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2B7946-B7F5-8511-0C4F-20CD73C98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9DA9C7C-6898-4EC3-63D7-74359B3AFD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726B456-6DFA-5A4D-19AB-643FEBE72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14F691-13D4-9CF3-BA19-5E07C75DD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F2CE735-B4D2-82B5-E547-6C33BAFD0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863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DFCB40D-C568-78CB-8B3F-D0F8B7CFD0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A735C5-53E6-D8F1-0FD0-A21A056A0A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4F583A5-26A2-DD10-510D-34F81D48B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301A786-BB0B-59BB-2AE8-578A4B152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F375697-4758-D2F2-D9D1-EA8F3E67D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6754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FC9624-2923-2E0E-9024-AC4782C46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52258EE-8495-AAF2-9B5E-B2307306B0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647D785-8B83-A40C-9F25-CE5400464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0E3BA19-7A43-1496-8A47-1E1754520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766459-7A28-8F97-8EF2-0CFC2B13E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9107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BE8467-ADCE-7892-8861-D02AFCC0AF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D29F05E-ACC4-613B-6868-DA21B48D2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29FB3A-85B5-B747-0045-2249077CE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B3FBDA-FA8D-AB5F-E71A-AA06A0A0E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F87042A-BB7B-81BD-40AF-47F917C02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7893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CE22A8E-B049-497E-3725-D067C5D89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A46B14E-E7BB-524C-4F9B-FE276E799D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E60C780-8A2E-2C1B-630D-76525AB2A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507C2F5-0DEC-6674-819A-292296F9B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41C0430-9202-1DCE-3617-150376A5D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CB6AAD4-977E-77A4-6339-B42AE1202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4153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27AF74-3A28-6582-0299-4735422AF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AFA5B47-D825-BCA7-9B96-E0EE7CB6EA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CE19A57-E3EA-F158-846D-B650924716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9C60E6A-5740-C1B2-3B7E-95AAC8A704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DC3AD5F4-DA0C-FF13-54C3-4A6CB50E7A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D978946-A574-44EF-4803-A849D3882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D655114-50DB-1D53-074C-601BA4AD3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7EC50B1-D62C-0624-340B-02E54BC8F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4358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74A99A-0F39-52CD-9B9A-149B66F07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E5CB958-481B-D886-5A06-5083C39EE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A97731A-377E-1E4A-35E4-EAE58E52E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0F7CB48-6DF5-0C63-C022-441965750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70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C1170A6-98D0-B317-95D3-899CF2428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E9AE9A9-423F-7AC9-C1E1-97C7573B0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22CF7E02-7045-7438-3A74-2EB79311F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5999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50F5AAF-DCD9-71E6-2F09-7FF346FBA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A48673F-46EA-DEED-96F8-6F31D18B1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2A15696-5136-6656-F629-720E6CE54C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2580C59-6F84-CE82-B905-ECBC73C58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CE1E272-E51B-B755-B379-A32CCDF48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A969AF7-4BE8-5AB7-1C3F-12E8F63B2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2617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3C7785-BEE5-3C5E-26E1-770881DED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5B7A897-1A79-FDCE-7731-18EBDEE02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56C43F0-79BE-8FA1-261D-C8C0456647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80AF5E4-28E6-1AF5-3CA1-5FA92F18B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A1104C0-C020-D330-7A38-DFE00F076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F70DE76-D314-BF89-E766-E85332529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88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C804E16-608C-33EA-A5F3-A03192880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2F6363B-1E38-706C-D37D-1E1CD0820E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2468042-38BD-257A-69AE-BD2D4B7C40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9C2C20-0862-49B7-AA4B-CDE26C620209}" type="datetimeFigureOut">
              <a:rPr lang="es-ES" smtClean="0"/>
              <a:t>18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07194A0-F7B4-29F3-2275-2FEBC62B4B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F7EA7E4-9750-5CB6-7E40-D229FE7BF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F011D3-94BA-46CA-948E-4D9657A859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6027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openxmlformats.org/officeDocument/2006/relationships/image" Target="../media/image9.png"/><Relationship Id="rId26" Type="http://schemas.openxmlformats.org/officeDocument/2006/relationships/image" Target="../media/image16.png"/><Relationship Id="rId39" Type="http://schemas.openxmlformats.org/officeDocument/2006/relationships/image" Target="../media/image26.png"/><Relationship Id="rId21" Type="http://schemas.openxmlformats.org/officeDocument/2006/relationships/image" Target="../media/image12.png"/><Relationship Id="rId34" Type="http://schemas.openxmlformats.org/officeDocument/2006/relationships/image" Target="../media/image22.png"/><Relationship Id="rId42" Type="http://schemas.openxmlformats.org/officeDocument/2006/relationships/image" Target="../media/image28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9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8.wdp"/><Relationship Id="rId32" Type="http://schemas.openxmlformats.org/officeDocument/2006/relationships/image" Target="../media/image21.png"/><Relationship Id="rId37" Type="http://schemas.openxmlformats.org/officeDocument/2006/relationships/image" Target="../media/image24.png"/><Relationship Id="rId40" Type="http://schemas.openxmlformats.org/officeDocument/2006/relationships/image" Target="../media/image27.png"/><Relationship Id="rId45" Type="http://schemas.openxmlformats.org/officeDocument/2006/relationships/image" Target="../media/image31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4.png"/><Relationship Id="rId28" Type="http://schemas.openxmlformats.org/officeDocument/2006/relationships/image" Target="../media/image18.png"/><Relationship Id="rId36" Type="http://schemas.microsoft.com/office/2007/relationships/hdphoto" Target="../media/hdphoto11.wdp"/><Relationship Id="rId10" Type="http://schemas.microsoft.com/office/2007/relationships/hdphoto" Target="../media/hdphoto4.wdp"/><Relationship Id="rId19" Type="http://schemas.openxmlformats.org/officeDocument/2006/relationships/image" Target="../media/image10.png"/><Relationship Id="rId31" Type="http://schemas.microsoft.com/office/2007/relationships/hdphoto" Target="../media/hdphoto9.wdp"/><Relationship Id="rId44" Type="http://schemas.openxmlformats.org/officeDocument/2006/relationships/image" Target="../media/image30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image" Target="../media/image13.png"/><Relationship Id="rId27" Type="http://schemas.openxmlformats.org/officeDocument/2006/relationships/image" Target="../media/image17.png"/><Relationship Id="rId30" Type="http://schemas.openxmlformats.org/officeDocument/2006/relationships/image" Target="../media/image20.png"/><Relationship Id="rId35" Type="http://schemas.openxmlformats.org/officeDocument/2006/relationships/image" Target="../media/image23.png"/><Relationship Id="rId43" Type="http://schemas.openxmlformats.org/officeDocument/2006/relationships/image" Target="../media/image29.png"/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5.png"/><Relationship Id="rId33" Type="http://schemas.microsoft.com/office/2007/relationships/hdphoto" Target="../media/hdphoto10.wdp"/><Relationship Id="rId38" Type="http://schemas.openxmlformats.org/officeDocument/2006/relationships/image" Target="../media/image25.png"/><Relationship Id="rId20" Type="http://schemas.openxmlformats.org/officeDocument/2006/relationships/image" Target="../media/image11.png"/><Relationship Id="rId41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EFF21383-88AB-2E3E-5478-95A65C66D90B}"/>
              </a:ext>
            </a:extLst>
          </p:cNvPr>
          <p:cNvSpPr txBox="1"/>
          <p:nvPr/>
        </p:nvSpPr>
        <p:spPr>
          <a:xfrm>
            <a:off x="688310" y="6060016"/>
            <a:ext cx="105403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1: BC</a:t>
            </a:r>
            <a:r>
              <a:rPr lang="en-US" sz="1200" baseline="-25000" dirty="0"/>
              <a:t>1</a:t>
            </a:r>
            <a:r>
              <a:rPr lang="en-US" sz="1200" dirty="0"/>
              <a:t>F</a:t>
            </a:r>
            <a:r>
              <a:rPr lang="en-US" sz="1200" baseline="-25000" dirty="0"/>
              <a:t>1</a:t>
            </a:r>
            <a:r>
              <a:rPr lang="en-US" sz="1200" dirty="0"/>
              <a:t> and Parental lines cotyledon test to determine presence of resistance against </a:t>
            </a:r>
            <a:r>
              <a:rPr lang="en-US" sz="1200" i="1" dirty="0"/>
              <a:t>Leptosphaeria </a:t>
            </a:r>
            <a:r>
              <a:rPr lang="en-US" sz="1200" i="1" dirty="0" err="1"/>
              <a:t>maculans</a:t>
            </a:r>
            <a:r>
              <a:rPr lang="en-US" sz="1200" i="1" dirty="0"/>
              <a:t>  </a:t>
            </a:r>
            <a:r>
              <a:rPr lang="en-US" sz="1200" dirty="0"/>
              <a:t>IBCN02 spores. The N codes represent </a:t>
            </a:r>
            <a:r>
              <a:rPr lang="en-US" sz="1200" i="1" dirty="0"/>
              <a:t>Brassica napus </a:t>
            </a:r>
            <a:r>
              <a:rPr lang="en-US" sz="1200" dirty="0"/>
              <a:t>genotypes:  </a:t>
            </a:r>
            <a:r>
              <a:rPr lang="es-CL" sz="1200" dirty="0"/>
              <a:t>N5 = </a:t>
            </a:r>
            <a:r>
              <a:rPr lang="es-CL" sz="1200" dirty="0" err="1"/>
              <a:t>Boomer</a:t>
            </a:r>
            <a:r>
              <a:rPr lang="es-CL" sz="1200" dirty="0"/>
              <a:t>; N8  = </a:t>
            </a:r>
            <a:r>
              <a:rPr lang="es-CL" sz="1200" dirty="0" err="1"/>
              <a:t>Ningyou</a:t>
            </a:r>
            <a:r>
              <a:rPr lang="es-CL" sz="1200" dirty="0"/>
              <a:t> 7; N14 = </a:t>
            </a:r>
            <a:r>
              <a:rPr lang="es-CL" sz="1200" dirty="0" err="1"/>
              <a:t>Darmor</a:t>
            </a:r>
            <a:r>
              <a:rPr lang="es-CL" sz="1200" dirty="0"/>
              <a:t>; N15 =MSL007. </a:t>
            </a:r>
            <a:endParaRPr lang="es-ES" sz="1200" dirty="0"/>
          </a:p>
        </p:txBody>
      </p:sp>
      <p:grpSp>
        <p:nvGrpSpPr>
          <p:cNvPr id="79" name="Grupo 78">
            <a:extLst>
              <a:ext uri="{FF2B5EF4-FFF2-40B4-BE49-F238E27FC236}">
                <a16:creationId xmlns:a16="http://schemas.microsoft.com/office/drawing/2014/main" id="{32499A9D-A6BA-91DA-0700-39861BEB7286}"/>
              </a:ext>
            </a:extLst>
          </p:cNvPr>
          <p:cNvGrpSpPr/>
          <p:nvPr/>
        </p:nvGrpSpPr>
        <p:grpSpPr>
          <a:xfrm>
            <a:off x="272091" y="264415"/>
            <a:ext cx="10956524" cy="5594123"/>
            <a:chOff x="272091" y="264415"/>
            <a:chExt cx="10956524" cy="5594123"/>
          </a:xfrm>
        </p:grpSpPr>
        <p:sp>
          <p:nvSpPr>
            <p:cNvPr id="22" name="Rectángulo 21">
              <a:extLst>
                <a:ext uri="{FF2B5EF4-FFF2-40B4-BE49-F238E27FC236}">
                  <a16:creationId xmlns:a16="http://schemas.microsoft.com/office/drawing/2014/main" id="{35FBCBF0-DC0B-5E2B-EF0B-E4E390AA507C}"/>
                </a:ext>
              </a:extLst>
            </p:cNvPr>
            <p:cNvSpPr/>
            <p:nvPr/>
          </p:nvSpPr>
          <p:spPr>
            <a:xfrm>
              <a:off x="733647" y="264415"/>
              <a:ext cx="10463069" cy="5594123"/>
            </a:xfrm>
            <a:prstGeom prst="rect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00"/>
            </a:p>
          </p:txBody>
        </p: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DD7E3F3F-278E-18E0-650D-46A7722002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ackgroundRemoval t="53846" b="89904" l="7299" r="80292">
                          <a14:foregroundMark x1="80292" y1="80288" x2="80292" y2="80288"/>
                          <a14:foregroundMark x1="71533" y1="89904" x2="71533" y2="89904"/>
                          <a14:foregroundMark x1="7299" y1="78846" x2="7299" y2="78846"/>
                          <a14:foregroundMark x1="47445" y1="53846" x2="47445" y2="53846"/>
                        </a14:backgroundRemoval>
                      </a14:imgEffect>
                    </a14:imgLayer>
                  </a14:imgProps>
                </a:ext>
              </a:extLst>
            </a:blip>
            <a:srcRect t="51106" r="11546" b="5930"/>
            <a:stretch>
              <a:fillRect/>
            </a:stretch>
          </p:blipFill>
          <p:spPr>
            <a:xfrm rot="10800000">
              <a:off x="5796145" y="699529"/>
              <a:ext cx="787210" cy="603062"/>
            </a:xfrm>
            <a:prstGeom prst="rect">
              <a:avLst/>
            </a:prstGeom>
          </p:spPr>
        </p:pic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F7C6A0AA-4853-5E60-8134-A7B7DEADEA1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9890" b="89835" l="9122" r="89865">
                          <a14:foregroundMark x1="9122" y1="68956" x2="9122" y2="68956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9723577">
              <a:off x="6928031" y="668948"/>
              <a:ext cx="787210" cy="787210"/>
            </a:xfrm>
            <a:prstGeom prst="rect">
              <a:avLst/>
            </a:prstGeom>
          </p:spPr>
        </p:pic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7F9F2AF0-12CD-7CB7-A4F1-BA4EEFB6E19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14286" b="89796" l="22925" r="80632">
                          <a14:foregroundMark x1="48221" y1="86735" x2="48221" y2="86735"/>
                          <a14:foregroundMark x1="41107" y1="90306" x2="41107" y2="90306"/>
                          <a14:foregroundMark x1="23715" y1="59694" x2="23715" y2="59694"/>
                          <a14:foregroundMark x1="77470" y1="57653" x2="77470" y2="57653"/>
                          <a14:foregroundMark x1="80632" y1="57653" x2="80632" y2="57653"/>
                        </a14:backgroundRemoval>
                      </a14:imgEffect>
                    </a14:imgLayer>
                  </a14:imgProps>
                </a:ext>
              </a:extLst>
            </a:blip>
            <a:srcRect l="18772" t="5708" r="15959" b="7163"/>
            <a:stretch>
              <a:fillRect/>
            </a:stretch>
          </p:blipFill>
          <p:spPr>
            <a:xfrm rot="10800000">
              <a:off x="4650077" y="696765"/>
              <a:ext cx="732532" cy="787209"/>
            </a:xfrm>
            <a:prstGeom prst="rect">
              <a:avLst/>
            </a:prstGeom>
          </p:spPr>
        </p:pic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3FAFB8DE-B0A4-0608-46A7-0B779B1250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18889" b="80556" l="12717" r="87283">
                          <a14:foregroundMark x1="35549" y1="79444" x2="35549" y2="79444"/>
                          <a14:foregroundMark x1="34971" y1="81111" x2="34971" y2="81111"/>
                          <a14:foregroundMark x1="12717" y1="57222" x2="12717" y2="57222"/>
                          <a14:foregroundMark x1="82659" y1="64722" x2="82659" y2="64722"/>
                          <a14:foregroundMark x1="87572" y1="61389" x2="87572" y2="61389"/>
                          <a14:foregroundMark x1="56358" y1="18889" x2="56358" y2="18889"/>
                        </a14:backgroundRemoval>
                      </a14:imgEffect>
                    </a14:imgLayer>
                  </a14:imgProps>
                </a:ext>
              </a:extLst>
            </a:blip>
            <a:srcRect l="8186" t="13722" r="11089" b="14285"/>
            <a:stretch>
              <a:fillRect/>
            </a:stretch>
          </p:blipFill>
          <p:spPr>
            <a:xfrm rot="10800000">
              <a:off x="3606334" y="615993"/>
              <a:ext cx="714738" cy="787210"/>
            </a:xfrm>
            <a:prstGeom prst="rect">
              <a:avLst/>
            </a:prstGeom>
          </p:spPr>
        </p:pic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68877CD4-5228-C541-200D-AEA821721A6D}"/>
                </a:ext>
              </a:extLst>
            </p:cNvPr>
            <p:cNvGrpSpPr>
              <a:grpSpLocks noChangeAspect="1"/>
            </p:cNvGrpSpPr>
            <p:nvPr/>
          </p:nvGrpSpPr>
          <p:grpSpPr>
            <a:xfrm rot="10800000">
              <a:off x="9911884" y="678834"/>
              <a:ext cx="819329" cy="1038610"/>
              <a:chOff x="2460686" y="514750"/>
              <a:chExt cx="1612130" cy="2163237"/>
            </a:xfrm>
          </p:grpSpPr>
          <p:pic>
            <p:nvPicPr>
              <p:cNvPr id="23" name="Imagen 22">
                <a:extLst>
                  <a:ext uri="{FF2B5EF4-FFF2-40B4-BE49-F238E27FC236}">
                    <a16:creationId xmlns:a16="http://schemas.microsoft.com/office/drawing/2014/main" id="{82F885E9-9059-C9CF-0382-F239EA40D1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ackgroundRemoval t="20362" b="85068" l="15301" r="81421">
                            <a14:foregroundMark x1="81421" y1="68326" x2="81421" y2="68326"/>
                            <a14:foregroundMark x1="65027" y1="83710" x2="65027" y2="83710"/>
                            <a14:foregroundMark x1="30055" y1="85520" x2="30055" y2="85520"/>
                            <a14:foregroundMark x1="15301" y1="60181" x2="15301" y2="60181"/>
                          </a14:backgroundRemoval>
                        </a14:imgEffect>
                      </a14:imgLayer>
                    </a14:imgProps>
                  </a:ext>
                </a:extLst>
              </a:blip>
              <a:srcRect l="10700" t="12806" r="11151" b="9315"/>
              <a:stretch>
                <a:fillRect/>
              </a:stretch>
            </p:blipFill>
            <p:spPr>
              <a:xfrm>
                <a:off x="2710431" y="1038371"/>
                <a:ext cx="1362385" cy="1639616"/>
              </a:xfrm>
              <a:prstGeom prst="rect">
                <a:avLst/>
              </a:prstGeom>
            </p:spPr>
          </p:pic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8D42113F-FF8C-43AB-D87D-345D11125350}"/>
                  </a:ext>
                </a:extLst>
              </p:cNvPr>
              <p:cNvSpPr txBox="1"/>
              <p:nvPr/>
            </p:nvSpPr>
            <p:spPr>
              <a:xfrm rot="10800000">
                <a:off x="2460686" y="514750"/>
                <a:ext cx="1345734" cy="641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CL" sz="1400" dirty="0">
                    <a:solidFill>
                      <a:schemeClr val="bg1"/>
                    </a:solidFill>
                  </a:rPr>
                  <a:t>IX13</a:t>
                </a:r>
                <a:endParaRPr lang="es-ES" sz="14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29" name="Grupo 28">
              <a:extLst>
                <a:ext uri="{FF2B5EF4-FFF2-40B4-BE49-F238E27FC236}">
                  <a16:creationId xmlns:a16="http://schemas.microsoft.com/office/drawing/2014/main" id="{00E55CEA-C6E2-CB31-0797-3029DDEDCC6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904209" y="678835"/>
              <a:ext cx="787209" cy="1017429"/>
              <a:chOff x="685826" y="1318563"/>
              <a:chExt cx="3164442" cy="4151681"/>
            </a:xfrm>
          </p:grpSpPr>
          <p:pic>
            <p:nvPicPr>
              <p:cNvPr id="26" name="Imagen 25">
                <a:extLst>
                  <a:ext uri="{FF2B5EF4-FFF2-40B4-BE49-F238E27FC236}">
                    <a16:creationId xmlns:a16="http://schemas.microsoft.com/office/drawing/2014/main" id="{8FDE64C2-65BB-982D-A800-9327B02486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ackgroundRemoval t="9544" b="87552" l="9847" r="94311">
                            <a14:foregroundMark x1="94311" y1="62033" x2="94311" y2="62033"/>
                            <a14:foregroundMark x1="32823" y1="87552" x2="32823" y2="87552"/>
                          </a14:backgroundRemoval>
                        </a14:imgEffect>
                      </a14:imgLayer>
                    </a14:imgProps>
                  </a:ext>
                </a:extLst>
              </a:blip>
              <a:srcRect b="3754"/>
              <a:stretch>
                <a:fillRect/>
              </a:stretch>
            </p:blipFill>
            <p:spPr>
              <a:xfrm rot="10800000">
                <a:off x="685826" y="1318563"/>
                <a:ext cx="3164442" cy="3212258"/>
              </a:xfrm>
              <a:prstGeom prst="rect">
                <a:avLst/>
              </a:prstGeom>
            </p:spPr>
          </p:pic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B93703F5-2A76-728F-52A8-394CF2FF55E1}"/>
                  </a:ext>
                </a:extLst>
              </p:cNvPr>
              <p:cNvSpPr txBox="1"/>
              <p:nvPr/>
            </p:nvSpPr>
            <p:spPr>
              <a:xfrm>
                <a:off x="1009362" y="4214341"/>
                <a:ext cx="2691349" cy="12559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CL" sz="1400" dirty="0">
                    <a:solidFill>
                      <a:schemeClr val="bg1"/>
                    </a:solidFill>
                  </a:rPr>
                  <a:t>IX7</a:t>
                </a:r>
                <a:endParaRPr lang="es-ES" sz="14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D64415CA-7B55-E213-459E-8141E570D9D7}"/>
                </a:ext>
              </a:extLst>
            </p:cNvPr>
            <p:cNvSpPr txBox="1"/>
            <p:nvPr/>
          </p:nvSpPr>
          <p:spPr>
            <a:xfrm>
              <a:off x="3568632" y="301428"/>
              <a:ext cx="40776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i="1" dirty="0" err="1">
                  <a:solidFill>
                    <a:schemeClr val="bg1"/>
                  </a:solidFill>
                </a:rPr>
                <a:t>Brassica</a:t>
              </a:r>
              <a:r>
                <a:rPr lang="es-CL" sz="1400" i="1" dirty="0">
                  <a:solidFill>
                    <a:schemeClr val="bg1"/>
                  </a:solidFill>
                </a:rPr>
                <a:t> </a:t>
              </a:r>
              <a:r>
                <a:rPr lang="es-CL" sz="1400" i="1" dirty="0" err="1">
                  <a:solidFill>
                    <a:schemeClr val="bg1"/>
                  </a:solidFill>
                </a:rPr>
                <a:t>napus</a:t>
              </a:r>
              <a:endParaRPr lang="es-CL" sz="1400" i="1" dirty="0">
                <a:solidFill>
                  <a:schemeClr val="bg1"/>
                </a:solidFill>
              </a:endParaRPr>
            </a:p>
            <a:p>
              <a:pPr algn="ctr"/>
              <a:endParaRPr lang="es-ES" sz="1400" i="1" dirty="0">
                <a:solidFill>
                  <a:schemeClr val="bg1"/>
                </a:solidFill>
              </a:endParaRP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FCD13773-F143-605F-2969-30C133865E68}"/>
                </a:ext>
              </a:extLst>
            </p:cNvPr>
            <p:cNvSpPr txBox="1"/>
            <p:nvPr/>
          </p:nvSpPr>
          <p:spPr>
            <a:xfrm>
              <a:off x="8871823" y="301428"/>
              <a:ext cx="17324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i="1" dirty="0" err="1">
                  <a:solidFill>
                    <a:schemeClr val="bg1"/>
                  </a:solidFill>
                </a:rPr>
                <a:t>Brassica</a:t>
              </a:r>
              <a:r>
                <a:rPr lang="es-CL" sz="1400" i="1" dirty="0">
                  <a:solidFill>
                    <a:schemeClr val="bg1"/>
                  </a:solidFill>
                </a:rPr>
                <a:t> </a:t>
              </a:r>
              <a:r>
                <a:rPr lang="es-CL" sz="1400" i="1" dirty="0" err="1">
                  <a:solidFill>
                    <a:schemeClr val="bg1"/>
                  </a:solidFill>
                </a:rPr>
                <a:t>nigra</a:t>
              </a:r>
              <a:endParaRPr lang="es-CL" sz="1400" i="1" dirty="0">
                <a:solidFill>
                  <a:schemeClr val="bg1"/>
                </a:solidFill>
              </a:endParaRPr>
            </a:p>
            <a:p>
              <a:pPr algn="ctr"/>
              <a:endParaRPr lang="es-ES" sz="1400" i="1" dirty="0">
                <a:solidFill>
                  <a:schemeClr val="bg1"/>
                </a:solidFill>
              </a:endParaRPr>
            </a:p>
          </p:txBody>
        </p:sp>
        <p:cxnSp>
          <p:nvCxnSpPr>
            <p:cNvPr id="3" name="Conector recto 2">
              <a:extLst>
                <a:ext uri="{FF2B5EF4-FFF2-40B4-BE49-F238E27FC236}">
                  <a16:creationId xmlns:a16="http://schemas.microsoft.com/office/drawing/2014/main" id="{6366C2CE-A35E-4997-1C39-A3260986601C}"/>
                </a:ext>
              </a:extLst>
            </p:cNvPr>
            <p:cNvCxnSpPr>
              <a:cxnSpLocks/>
            </p:cNvCxnSpPr>
            <p:nvPr/>
          </p:nvCxnSpPr>
          <p:spPr>
            <a:xfrm>
              <a:off x="1808334" y="1777424"/>
              <a:ext cx="9388382" cy="0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ctor recto 8">
              <a:extLst>
                <a:ext uri="{FF2B5EF4-FFF2-40B4-BE49-F238E27FC236}">
                  <a16:creationId xmlns:a16="http://schemas.microsoft.com/office/drawing/2014/main" id="{5E453EA4-CC91-9212-FCB8-1C6AD4469C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39727" y="2907779"/>
              <a:ext cx="9356989" cy="11201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id="{DDCD2F2B-0404-693B-8C71-81724543FCCF}"/>
                </a:ext>
              </a:extLst>
            </p:cNvPr>
            <p:cNvCxnSpPr>
              <a:cxnSpLocks/>
            </p:cNvCxnSpPr>
            <p:nvPr/>
          </p:nvCxnSpPr>
          <p:spPr>
            <a:xfrm>
              <a:off x="1839727" y="3874944"/>
              <a:ext cx="9388888" cy="0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6637511E-E800-CBD9-256A-91F5DE19F43B}"/>
                </a:ext>
              </a:extLst>
            </p:cNvPr>
            <p:cNvCxnSpPr>
              <a:cxnSpLocks/>
            </p:cNvCxnSpPr>
            <p:nvPr/>
          </p:nvCxnSpPr>
          <p:spPr>
            <a:xfrm>
              <a:off x="1839727" y="4818763"/>
              <a:ext cx="9356989" cy="0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" name="Grupo 24">
              <a:extLst>
                <a:ext uri="{FF2B5EF4-FFF2-40B4-BE49-F238E27FC236}">
                  <a16:creationId xmlns:a16="http://schemas.microsoft.com/office/drawing/2014/main" id="{2B209594-C909-FBC0-87C2-84644EC6763C}"/>
                </a:ext>
              </a:extLst>
            </p:cNvPr>
            <p:cNvGrpSpPr/>
            <p:nvPr/>
          </p:nvGrpSpPr>
          <p:grpSpPr>
            <a:xfrm>
              <a:off x="3438971" y="2053416"/>
              <a:ext cx="7515697" cy="865564"/>
              <a:chOff x="2289890" y="2114550"/>
              <a:chExt cx="7515697" cy="865564"/>
            </a:xfrm>
          </p:grpSpPr>
          <p:pic>
            <p:nvPicPr>
              <p:cNvPr id="36" name="Imagen 35">
                <a:extLst>
                  <a:ext uri="{FF2B5EF4-FFF2-40B4-BE49-F238E27FC236}">
                    <a16:creationId xmlns:a16="http://schemas.microsoft.com/office/drawing/2014/main" id="{DACABC9F-4029-A395-2147-20F6633454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40509" b="49576" l="50566" r="56636">
                            <a14:foregroundMark x1="53421" y1="49576" x2="53421" y2="49576"/>
                          </a14:backgroundRemoval>
                        </a14:imgEffect>
                      </a14:imgLayer>
                    </a14:imgProps>
                  </a:ext>
                </a:extLst>
              </a:blip>
              <a:srcRect l="49815" t="39444" r="42581" b="49584"/>
              <a:stretch>
                <a:fillRect/>
              </a:stretch>
            </p:blipFill>
            <p:spPr>
              <a:xfrm>
                <a:off x="5715002" y="2162176"/>
                <a:ext cx="782204" cy="752475"/>
              </a:xfrm>
              <a:prstGeom prst="rect">
                <a:avLst/>
              </a:prstGeom>
            </p:spPr>
          </p:pic>
          <p:pic>
            <p:nvPicPr>
              <p:cNvPr id="37" name="Imagen 36">
                <a:extLst>
                  <a:ext uri="{FF2B5EF4-FFF2-40B4-BE49-F238E27FC236}">
                    <a16:creationId xmlns:a16="http://schemas.microsoft.com/office/drawing/2014/main" id="{73C8155A-360B-1EAA-7699-8332D4933D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52083" b="60262" l="13966" r="21013">
                            <a14:foregroundMark x1="15792" y1="60262" x2="15792" y2="60262"/>
                          </a14:backgroundRemoval>
                        </a14:imgEffect>
                      </a14:imgLayer>
                    </a14:imgProps>
                  </a:ext>
                </a:extLst>
              </a:blip>
              <a:srcRect l="13102" t="51111" r="78102" b="38889"/>
              <a:stretch>
                <a:fillRect/>
              </a:stretch>
            </p:blipFill>
            <p:spPr>
              <a:xfrm rot="10800000">
                <a:off x="2289890" y="2181955"/>
                <a:ext cx="904876" cy="685800"/>
              </a:xfrm>
              <a:prstGeom prst="rect">
                <a:avLst/>
              </a:prstGeom>
            </p:spPr>
          </p:pic>
          <p:pic>
            <p:nvPicPr>
              <p:cNvPr id="38" name="Imagen 37">
                <a:extLst>
                  <a:ext uri="{FF2B5EF4-FFF2-40B4-BE49-F238E27FC236}">
                    <a16:creationId xmlns:a16="http://schemas.microsoft.com/office/drawing/2014/main" id="{39980734-7600-422A-F9C5-BEDC8870D4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48573" b="58333" l="25592" r="32639">
                            <a14:foregroundMark x1="32639" y1="55093" x2="32639" y2="55093"/>
                            <a14:foregroundMark x1="25592" y1="52932" x2="25592" y2="52932"/>
                          </a14:backgroundRemoval>
                        </a14:imgEffect>
                      </a14:imgLayer>
                    </a14:imgProps>
                  </a:ext>
                </a:extLst>
              </a:blip>
              <a:srcRect l="25324" t="47361" r="66528" b="40417"/>
              <a:stretch>
                <a:fillRect/>
              </a:stretch>
            </p:blipFill>
            <p:spPr>
              <a:xfrm rot="10800000">
                <a:off x="3357598" y="2130711"/>
                <a:ext cx="838202" cy="838201"/>
              </a:xfrm>
              <a:prstGeom prst="rect">
                <a:avLst/>
              </a:prstGeom>
            </p:spPr>
          </p:pic>
          <p:pic>
            <p:nvPicPr>
              <p:cNvPr id="39" name="Imagen 38">
                <a:extLst>
                  <a:ext uri="{FF2B5EF4-FFF2-40B4-BE49-F238E27FC236}">
                    <a16:creationId xmlns:a16="http://schemas.microsoft.com/office/drawing/2014/main" id="{724DFB8B-AAB6-5EA1-7E59-F0AC553B09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40278" b="50386" l="38735" r="46091">
                            <a14:foregroundMark x1="38760" y1="43827" x2="38760" y2="43827"/>
                            <a14:foregroundMark x1="44162" y1="40278" x2="44162" y2="40278"/>
                            <a14:foregroundMark x1="46091" y1="43943" x2="46091" y2="43943"/>
                            <a14:foregroundMark x1="41615" y1="50193" x2="41795" y2="50386"/>
                          </a14:backgroundRemoval>
                        </a14:imgEffect>
                      </a14:imgLayer>
                    </a14:imgProps>
                  </a:ext>
                </a:extLst>
              </a:blip>
              <a:srcRect l="38009" t="39305" r="53194" b="49028"/>
              <a:stretch>
                <a:fillRect/>
              </a:stretch>
            </p:blipFill>
            <p:spPr>
              <a:xfrm>
                <a:off x="4620853" y="2114550"/>
                <a:ext cx="904875" cy="800101"/>
              </a:xfrm>
              <a:prstGeom prst="rect">
                <a:avLst/>
              </a:prstGeom>
            </p:spPr>
          </p:pic>
          <p:pic>
            <p:nvPicPr>
              <p:cNvPr id="40" name="Imagen 39">
                <a:extLst>
                  <a:ext uri="{FF2B5EF4-FFF2-40B4-BE49-F238E27FC236}">
                    <a16:creationId xmlns:a16="http://schemas.microsoft.com/office/drawing/2014/main" id="{7A504E06-F48F-A58E-2CB0-4CE7720657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51813" b="59491" l="61934" r="68570">
                            <a14:foregroundMark x1="61934" y1="55903" x2="61934" y2="55903"/>
                          </a14:backgroundRemoval>
                        </a14:imgEffect>
                      </a14:imgLayer>
                    </a14:imgProps>
                  </a:ext>
                </a:extLst>
              </a:blip>
              <a:srcRect l="61342" t="50881" r="30602" b="39535"/>
              <a:stretch>
                <a:fillRect/>
              </a:stretch>
            </p:blipFill>
            <p:spPr>
              <a:xfrm rot="10800000">
                <a:off x="6798788" y="2209800"/>
                <a:ext cx="828675" cy="657226"/>
              </a:xfrm>
              <a:prstGeom prst="rect">
                <a:avLst/>
              </a:prstGeom>
            </p:spPr>
          </p:pic>
          <p:pic>
            <p:nvPicPr>
              <p:cNvPr id="41" name="Imagen 40">
                <a:extLst>
                  <a:ext uri="{FF2B5EF4-FFF2-40B4-BE49-F238E27FC236}">
                    <a16:creationId xmlns:a16="http://schemas.microsoft.com/office/drawing/2014/main" id="{E184579C-B93E-8847-6593-F538D037A5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39352" b="46798" l="71605" r="78241">
                            <a14:foregroundMark x1="78241" y1="41512" x2="78241" y2="41512"/>
                            <a14:foregroundMark x1="76800" y1="39352" x2="76800" y2="39352"/>
                          </a14:backgroundRemoval>
                        </a14:imgEffect>
                      </a14:imgLayer>
                    </a14:imgProps>
                  </a:ext>
                </a:extLst>
              </a:blip>
              <a:srcRect l="70787" t="38556" r="20973" b="52277"/>
              <a:stretch>
                <a:fillRect/>
              </a:stretch>
            </p:blipFill>
            <p:spPr>
              <a:xfrm>
                <a:off x="7816455" y="2258198"/>
                <a:ext cx="847725" cy="628650"/>
              </a:xfrm>
              <a:prstGeom prst="rect">
                <a:avLst/>
              </a:prstGeom>
            </p:spPr>
          </p:pic>
          <p:pic>
            <p:nvPicPr>
              <p:cNvPr id="42" name="Imagen 41">
                <a:extLst>
                  <a:ext uri="{FF2B5EF4-FFF2-40B4-BE49-F238E27FC236}">
                    <a16:creationId xmlns:a16="http://schemas.microsoft.com/office/drawing/2014/main" id="{CC6A0112-A8C3-FE00-C588-78136D24FD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52238" b="61960" l="83873" r="91487">
                            <a14:foregroundMark x1="85571" y1="61998" x2="85571" y2="61998"/>
                            <a14:foregroundMark x1="83873" y1="59105" x2="83873" y2="59105"/>
                          </a14:backgroundRemoval>
                        </a14:imgEffect>
                      </a14:imgLayer>
                    </a14:imgProps>
                  </a:ext>
                </a:extLst>
              </a:blip>
              <a:srcRect l="83101" t="51111" r="7546" b="37222"/>
              <a:stretch>
                <a:fillRect/>
              </a:stretch>
            </p:blipFill>
            <p:spPr>
              <a:xfrm rot="10800000">
                <a:off x="8843562" y="2180014"/>
                <a:ext cx="962025" cy="800100"/>
              </a:xfrm>
              <a:prstGeom prst="rect">
                <a:avLst/>
              </a:prstGeom>
            </p:spPr>
          </p:pic>
        </p:grpSp>
        <p:grpSp>
          <p:nvGrpSpPr>
            <p:cNvPr id="43" name="Grupo 42">
              <a:extLst>
                <a:ext uri="{FF2B5EF4-FFF2-40B4-BE49-F238E27FC236}">
                  <a16:creationId xmlns:a16="http://schemas.microsoft.com/office/drawing/2014/main" id="{8289BFC9-D9D0-6264-EB74-5E80724446B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418345" y="3016957"/>
              <a:ext cx="6493539" cy="852077"/>
              <a:chOff x="1804490" y="2778027"/>
              <a:chExt cx="7459692" cy="978856"/>
            </a:xfrm>
          </p:grpSpPr>
          <p:pic>
            <p:nvPicPr>
              <p:cNvPr id="44" name="Imagen 43">
                <a:extLst>
                  <a:ext uri="{FF2B5EF4-FFF2-40B4-BE49-F238E27FC236}">
                    <a16:creationId xmlns:a16="http://schemas.microsoft.com/office/drawing/2014/main" id="{3F4ADF3C-506B-4F62-225A-84341C04B2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60069" b="68866" l="3987" r="13092">
                            <a14:foregroundMark x1="13117" y1="67477" x2="13117" y2="67477"/>
                            <a14:foregroundMark x1="3987" y1="63850" x2="3987" y2="63850"/>
                            <a14:foregroundMark x1="7973" y1="60069" x2="7973" y2="60069"/>
                          </a14:backgroundRemoval>
                        </a14:imgEffect>
                      </a14:imgLayer>
                    </a14:imgProps>
                  </a:ext>
                </a:extLst>
              </a:blip>
              <a:srcRect l="3256" t="59647" r="85911" b="30076"/>
              <a:stretch>
                <a:fillRect/>
              </a:stretch>
            </p:blipFill>
            <p:spPr>
              <a:xfrm rot="10800000">
                <a:off x="1804490" y="2921740"/>
                <a:ext cx="1114425" cy="704850"/>
              </a:xfrm>
              <a:prstGeom prst="rect">
                <a:avLst/>
              </a:prstGeom>
            </p:spPr>
          </p:pic>
          <p:pic>
            <p:nvPicPr>
              <p:cNvPr id="45" name="Imagen 44">
                <a:extLst>
                  <a:ext uri="{FF2B5EF4-FFF2-40B4-BE49-F238E27FC236}">
                    <a16:creationId xmlns:a16="http://schemas.microsoft.com/office/drawing/2014/main" id="{CDEA9D25-A514-44FC-F8F1-AABC0F5F89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51235" b="62230" l="21656" r="32022">
                            <a14:foregroundMark x1="21682" y1="55324" x2="21682" y2="55324"/>
                            <a14:foregroundMark x1="32022" y1="53318" x2="32022" y2="53318"/>
                          </a14:backgroundRemoval>
                        </a14:imgEffect>
                      </a14:imgLayer>
                    </a14:imgProps>
                  </a:ext>
                </a:extLst>
              </a:blip>
              <a:srcRect l="20870" t="49862" r="66931" b="36379"/>
              <a:stretch>
                <a:fillRect/>
              </a:stretch>
            </p:blipFill>
            <p:spPr>
              <a:xfrm>
                <a:off x="3084298" y="2813301"/>
                <a:ext cx="1254869" cy="943582"/>
              </a:xfrm>
              <a:prstGeom prst="rect">
                <a:avLst/>
              </a:prstGeom>
            </p:spPr>
          </p:pic>
          <p:pic>
            <p:nvPicPr>
              <p:cNvPr id="46" name="Imagen 45">
                <a:extLst>
                  <a:ext uri="{FF2B5EF4-FFF2-40B4-BE49-F238E27FC236}">
                    <a16:creationId xmlns:a16="http://schemas.microsoft.com/office/drawing/2014/main" id="{7131E0BA-7B7F-9673-D988-691BB44493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49383" b="61150" l="40201" r="48483">
                            <a14:foregroundMark x1="40226" y1="53549" x2="40226" y2="53549"/>
                            <a14:foregroundMark x1="43107" y1="49421" x2="43107" y2="49421"/>
                            <a14:foregroundMark x1="48508" y1="53858" x2="48508" y2="53858"/>
                            <a14:foregroundMark x1="44830" y1="61150" x2="44830" y2="61150"/>
                          </a14:backgroundRemoval>
                        </a14:imgEffect>
                      </a14:imgLayer>
                    </a14:imgProps>
                  </a:ext>
                </a:extLst>
              </a:blip>
              <a:srcRect l="39467" t="48275" r="50604" b="37949"/>
              <a:stretch>
                <a:fillRect/>
              </a:stretch>
            </p:blipFill>
            <p:spPr>
              <a:xfrm>
                <a:off x="4537217" y="2812052"/>
                <a:ext cx="1021405" cy="944754"/>
              </a:xfrm>
              <a:prstGeom prst="rect">
                <a:avLst/>
              </a:prstGeom>
            </p:spPr>
          </p:pic>
          <p:pic>
            <p:nvPicPr>
              <p:cNvPr id="47" name="Imagen 46">
                <a:extLst>
                  <a:ext uri="{FF2B5EF4-FFF2-40B4-BE49-F238E27FC236}">
                    <a16:creationId xmlns:a16="http://schemas.microsoft.com/office/drawing/2014/main" id="{E293A23C-916A-ECDB-1008-D2A09BBB28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62037" b="72994" l="54655" r="64815">
                            <a14:foregroundMark x1="64480" y1="67052" x2="64480" y2="67052"/>
                            <a14:foregroundMark x1="64815" y1="66744" x2="64815" y2="66744"/>
                            <a14:foregroundMark x1="54681" y1="68441" x2="54681" y2="68441"/>
                            <a14:foregroundMark x1="60751" y1="62037" x2="60751" y2="62037"/>
                          </a14:backgroundRemoval>
                        </a14:imgEffect>
                      </a14:imgLayer>
                    </a14:imgProps>
                  </a:ext>
                </a:extLst>
              </a:blip>
              <a:srcRect l="53684" t="61067" r="34590" b="25599"/>
              <a:stretch>
                <a:fillRect/>
              </a:stretch>
            </p:blipFill>
            <p:spPr>
              <a:xfrm rot="10800000">
                <a:off x="5695504" y="2778027"/>
                <a:ext cx="1206230" cy="914401"/>
              </a:xfrm>
              <a:prstGeom prst="rect">
                <a:avLst/>
              </a:prstGeom>
            </p:spPr>
          </p:pic>
          <p:pic>
            <p:nvPicPr>
              <p:cNvPr id="48" name="Imagen 47">
                <a:extLst>
                  <a:ext uri="{FF2B5EF4-FFF2-40B4-BE49-F238E27FC236}">
                    <a16:creationId xmlns:a16="http://schemas.microsoft.com/office/drawing/2014/main" id="{64CEEFF8-79C1-09B3-2F18-CCFC8B1CC3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63079" b="72569" l="69342" r="76209">
                            <a14:foregroundMark x1="76209" y1="68480" x2="76209" y2="68480"/>
                            <a14:foregroundMark x1="74331" y1="72569" x2="74331" y2="72569"/>
                          </a14:backgroundRemoval>
                        </a14:imgEffect>
                      </a14:imgLayer>
                    </a14:imgProps>
                  </a:ext>
                </a:extLst>
              </a:blip>
              <a:srcRect l="68530" t="61958" r="23054" b="26269"/>
              <a:stretch>
                <a:fillRect/>
              </a:stretch>
            </p:blipFill>
            <p:spPr>
              <a:xfrm rot="10800000">
                <a:off x="7203611" y="2894702"/>
                <a:ext cx="865762" cy="807396"/>
              </a:xfrm>
              <a:prstGeom prst="rect">
                <a:avLst/>
              </a:prstGeom>
            </p:spPr>
          </p:pic>
          <p:pic>
            <p:nvPicPr>
              <p:cNvPr id="49" name="Imagen 48">
                <a:extLst>
                  <a:ext uri="{FF2B5EF4-FFF2-40B4-BE49-F238E27FC236}">
                    <a16:creationId xmlns:a16="http://schemas.microsoft.com/office/drawing/2014/main" id="{2D809CB8-7F49-8614-63D7-03ED0A77A7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ackgroundRemoval t="50309" b="60224" l="82665" r="91667">
                            <a14:foregroundMark x1="82716" y1="52739" x2="82716" y2="52739"/>
                            <a14:foregroundMark x1="84594" y1="50347" x2="84594" y2="50347"/>
                            <a14:foregroundMark x1="91667" y1="55131" x2="91667" y2="55131"/>
                          </a14:backgroundRemoval>
                        </a14:imgEffect>
                      </a14:imgLayer>
                    </a14:imgProps>
                  </a:ext>
                </a:extLst>
              </a:blip>
              <a:srcRect l="82200" t="49641" r="7871" b="38586"/>
              <a:stretch>
                <a:fillRect/>
              </a:stretch>
            </p:blipFill>
            <p:spPr>
              <a:xfrm>
                <a:off x="8242777" y="2898573"/>
                <a:ext cx="1021405" cy="807396"/>
              </a:xfrm>
              <a:prstGeom prst="rect">
                <a:avLst/>
              </a:prstGeom>
            </p:spPr>
          </p:pic>
        </p:grpSp>
        <p:pic>
          <p:nvPicPr>
            <p:cNvPr id="50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F3CF5171-20DE-B9B9-8BAF-3472B6F257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ackgroundRemoval t="58916" b="66518" l="7898" r="13854">
                          <a14:foregroundMark x1="13854" y1="63809" x2="13854" y2="6380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12" t="57995" r="85707" b="32500"/>
            <a:stretch>
              <a:fillRect/>
            </a:stretch>
          </p:blipFill>
          <p:spPr>
            <a:xfrm rot="10800000">
              <a:off x="3568633" y="4035848"/>
              <a:ext cx="617286" cy="552450"/>
            </a:xfrm>
            <a:prstGeom prst="rect">
              <a:avLst/>
            </a:prstGeom>
          </p:spPr>
        </p:pic>
        <p:pic>
          <p:nvPicPr>
            <p:cNvPr id="51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1847202F-0B09-D604-282A-32314AAE80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ackgroundRemoval t="48761" b="56577" l="18824" r="23492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40" t="47784" r="75924" b="42446"/>
            <a:stretch>
              <a:fillRect/>
            </a:stretch>
          </p:blipFill>
          <p:spPr>
            <a:xfrm>
              <a:off x="4711582" y="4048128"/>
              <a:ext cx="508819" cy="567813"/>
            </a:xfrm>
            <a:prstGeom prst="rect">
              <a:avLst/>
            </a:prstGeom>
          </p:spPr>
        </p:pic>
        <p:pic>
          <p:nvPicPr>
            <p:cNvPr id="52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50678238-E4FD-AAE4-D2EC-A1445CECDC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ackgroundRemoval t="60453" b="72099" l="30863" r="39030">
                          <a14:foregroundMark x1="32722" y1="72139" x2="32722" y2="72139"/>
                          <a14:foregroundMark x1="39030" y1="69389" x2="39030" y2="69389"/>
                          <a14:foregroundMark x1="35256" y1="60453" x2="35256" y2="60453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12" t="59480" r="60106" b="26728"/>
            <a:stretch>
              <a:fillRect/>
            </a:stretch>
          </p:blipFill>
          <p:spPr>
            <a:xfrm rot="10800000">
              <a:off x="5784790" y="3950194"/>
              <a:ext cx="870155" cy="801547"/>
            </a:xfrm>
            <a:prstGeom prst="rect">
              <a:avLst/>
            </a:prstGeom>
          </p:spPr>
        </p:pic>
        <p:pic>
          <p:nvPicPr>
            <p:cNvPr id="53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C36DDAB1-CAC4-733B-68A4-709B955F6D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ackgroundRemoval t="62839" b="72099" l="42803" r="49919">
                          <a14:foregroundMark x1="49946" y1="69106" x2="49946" y2="69106"/>
                          <a14:foregroundMark x1="48032" y1="72099" x2="48032" y2="72099"/>
                          <a14:foregroundMark x1="42803" y1="69834" x2="42803" y2="6983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16" t="61725" r="49495" b="26728"/>
            <a:stretch>
              <a:fillRect/>
            </a:stretch>
          </p:blipFill>
          <p:spPr>
            <a:xfrm rot="10800000">
              <a:off x="7023764" y="3981994"/>
              <a:ext cx="722671" cy="671054"/>
            </a:xfrm>
            <a:prstGeom prst="rect">
              <a:avLst/>
            </a:prstGeom>
          </p:spPr>
        </p:pic>
        <p:pic>
          <p:nvPicPr>
            <p:cNvPr id="54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2E7927E4-7458-0D7D-248F-3A2399D5DB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ackgroundRemoval t="63405" b="69794" l="56334" r="62102">
                          <a14:foregroundMark x1="61833" y1="66963" x2="61833" y2="66963"/>
                          <a14:foregroundMark x1="56361" y1="67691" x2="56361" y2="67691"/>
                          <a14:foregroundMark x1="62102" y1="66761" x2="62102" y2="66761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25" t="62652" r="37493" b="29350"/>
            <a:stretch>
              <a:fillRect/>
            </a:stretch>
          </p:blipFill>
          <p:spPr>
            <a:xfrm rot="10800000">
              <a:off x="8162201" y="4117352"/>
              <a:ext cx="582561" cy="464792"/>
            </a:xfrm>
            <a:prstGeom prst="rect">
              <a:avLst/>
            </a:prstGeom>
          </p:spPr>
        </p:pic>
        <p:pic>
          <p:nvPicPr>
            <p:cNvPr id="55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B2D95A6F-AA15-9F3B-1690-FFDCF5D205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ackgroundRemoval t="61828" b="71088" l="70593" r="78464">
                          <a14:foregroundMark x1="78464" y1="67732" x2="78464" y2="67732"/>
                          <a14:foregroundMark x1="76280" y1="70926" x2="76280" y2="70926"/>
                          <a14:foregroundMark x1="72102" y1="71128" x2="72102" y2="71128"/>
                          <a14:foregroundMark x1="70593" y1="68338" x2="70593" y2="68338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867" t="60749" r="20744" b="27958"/>
            <a:stretch>
              <a:fillRect/>
            </a:stretch>
          </p:blipFill>
          <p:spPr>
            <a:xfrm rot="10800000">
              <a:off x="9084276" y="4003180"/>
              <a:ext cx="818536" cy="656304"/>
            </a:xfrm>
            <a:prstGeom prst="rect">
              <a:avLst/>
            </a:prstGeom>
          </p:spPr>
        </p:pic>
        <p:pic>
          <p:nvPicPr>
            <p:cNvPr id="56" name="Marcador de contenido 4" descr="Un conjunto de letras blancas en un fondo blanco&#10;&#10;El contenido generado por IA puede ser incorrecto.">
              <a:extLst>
                <a:ext uri="{FF2B5EF4-FFF2-40B4-BE49-F238E27FC236}">
                  <a16:creationId xmlns:a16="http://schemas.microsoft.com/office/drawing/2014/main" id="{89AF73BB-AA4E-696D-2586-F3A617A10F2A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ackgroundRemoval t="61666" b="70158" l="81968" r="89111">
                          <a14:foregroundMark x1="89164" y1="67853" x2="89164" y2="67853"/>
                          <a14:foregroundMark x1="86765" y1="70077" x2="86765" y2="70077"/>
                          <a14:foregroundMark x1="83612" y1="70198" x2="83612" y2="70198"/>
                          <a14:foregroundMark x1="81968" y1="67529" x2="81968" y2="67529"/>
                          <a14:foregroundMark x1="85310" y1="61666" x2="85310" y2="61666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370" t="60750" r="10171" b="29350"/>
            <a:stretch>
              <a:fillRect/>
            </a:stretch>
          </p:blipFill>
          <p:spPr>
            <a:xfrm rot="10800000">
              <a:off x="10098769" y="4078491"/>
              <a:ext cx="737420" cy="575405"/>
            </a:xfrm>
            <a:prstGeom prst="rect">
              <a:avLst/>
            </a:prstGeom>
          </p:spPr>
        </p:pic>
        <p:grpSp>
          <p:nvGrpSpPr>
            <p:cNvPr id="57" name="Grupo 56">
              <a:extLst>
                <a:ext uri="{FF2B5EF4-FFF2-40B4-BE49-F238E27FC236}">
                  <a16:creationId xmlns:a16="http://schemas.microsoft.com/office/drawing/2014/main" id="{802AD97B-F752-BF57-EC4A-5FB4358EEE5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454858" y="4818763"/>
              <a:ext cx="5643144" cy="951656"/>
              <a:chOff x="1704544" y="3261206"/>
              <a:chExt cx="6492401" cy="1094874"/>
            </a:xfrm>
          </p:grpSpPr>
          <p:pic>
            <p:nvPicPr>
              <p:cNvPr id="58" name="Imagen 57">
                <a:extLst>
                  <a:ext uri="{FF2B5EF4-FFF2-40B4-BE49-F238E27FC236}">
                    <a16:creationId xmlns:a16="http://schemas.microsoft.com/office/drawing/2014/main" id="{ACC003AA-7E64-1C03-64F5-45709DBBA7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0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ackgroundRemoval t="56211" b="69290" l="10211" r="17207">
                            <a14:foregroundMark x1="15201" y1="69290" x2="15201" y2="69290"/>
                            <a14:foregroundMark x1="17155" y1="65046" x2="17155" y2="65046"/>
                          </a14:backgroundRemoval>
                        </a14:imgEffect>
                      </a14:imgLayer>
                    </a14:imgProps>
                  </a:ext>
                </a:extLst>
              </a:blip>
              <a:srcRect l="9337" t="54619" r="81891" b="29415"/>
              <a:stretch>
                <a:fillRect/>
              </a:stretch>
            </p:blipFill>
            <p:spPr>
              <a:xfrm rot="10800000">
                <a:off x="1704544" y="3261206"/>
                <a:ext cx="902369" cy="1094874"/>
              </a:xfrm>
              <a:prstGeom prst="rect">
                <a:avLst/>
              </a:prstGeom>
            </p:spPr>
          </p:pic>
          <p:pic>
            <p:nvPicPr>
              <p:cNvPr id="59" name="Imagen 58">
                <a:extLst>
                  <a:ext uri="{FF2B5EF4-FFF2-40B4-BE49-F238E27FC236}">
                    <a16:creationId xmlns:a16="http://schemas.microsoft.com/office/drawing/2014/main" id="{8111B817-3F5B-53C3-04A8-1D7C836618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2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ackgroundRemoval t="45255" b="55247" l="26775" r="34311">
                            <a14:foregroundMark x1="26775" y1="48573" x2="26775" y2="48573"/>
                            <a14:foregroundMark x1="34311" y1="46373" x2="34311" y2="46373"/>
                          </a14:backgroundRemoval>
                        </a14:imgEffect>
                      </a14:imgLayer>
                    </a14:imgProps>
                  </a:ext>
                </a:extLst>
              </a:blip>
              <a:srcRect l="25935" t="44021" r="65293" b="43505"/>
              <a:stretch>
                <a:fillRect/>
              </a:stretch>
            </p:blipFill>
            <p:spPr>
              <a:xfrm>
                <a:off x="2976634" y="3388550"/>
                <a:ext cx="902370" cy="855407"/>
              </a:xfrm>
              <a:prstGeom prst="rect">
                <a:avLst/>
              </a:prstGeom>
            </p:spPr>
          </p:pic>
          <p:pic>
            <p:nvPicPr>
              <p:cNvPr id="61" name="Imagen 60">
                <a:extLst>
                  <a:ext uri="{FF2B5EF4-FFF2-40B4-BE49-F238E27FC236}">
                    <a16:creationId xmlns:a16="http://schemas.microsoft.com/office/drawing/2014/main" id="{45FA16EC-AFA6-4632-44F0-F7CFEB1929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ackgroundRemoval t="60378" b="71373" l="54347" r="63735">
                            <a14:foregroundMark x1="63760" y1="66975" x2="63760" y2="66975"/>
                            <a14:foregroundMark x1="54347" y1="67785" x2="54347" y2="67785"/>
                            <a14:foregroundMark x1="56739" y1="71412" x2="56739" y2="71412"/>
                            <a14:foregroundMark x1="58410" y1="60378" x2="58410" y2="60378"/>
                          </a14:backgroundRemoval>
                        </a14:imgEffect>
                      </a14:imgLayer>
                    </a14:imgProps>
                  </a:ext>
                </a:extLst>
              </a:blip>
              <a:srcRect l="53632" t="59175" r="35329" b="27491"/>
              <a:stretch>
                <a:fillRect/>
              </a:stretch>
            </p:blipFill>
            <p:spPr>
              <a:xfrm rot="10800000">
                <a:off x="4319834" y="3350814"/>
                <a:ext cx="1135627" cy="914400"/>
              </a:xfrm>
              <a:prstGeom prst="rect">
                <a:avLst/>
              </a:prstGeom>
            </p:spPr>
          </p:pic>
          <p:pic>
            <p:nvPicPr>
              <p:cNvPr id="62" name="Imagen 61">
                <a:extLst>
                  <a:ext uri="{FF2B5EF4-FFF2-40B4-BE49-F238E27FC236}">
                    <a16:creationId xmlns:a16="http://schemas.microsoft.com/office/drawing/2014/main" id="{64785815-15A1-D885-1D87-35D1A9685F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ackgroundRemoval t="59877" b="70139" l="68724" r="77778">
                            <a14:foregroundMark x1="75489" y1="69792" x2="75489" y2="69792"/>
                            <a14:foregroundMark x1="75746" y1="69676" x2="75746" y2="69676"/>
                            <a14:foregroundMark x1="77418" y1="64969" x2="77418" y2="64969"/>
                            <a14:foregroundMark x1="77829" y1="65856" x2="77829" y2="65856"/>
                            <a14:foregroundMark x1="77829" y1="65586" x2="77829" y2="65586"/>
                            <a14:foregroundMark x1="75154" y1="70177" x2="75154" y2="70177"/>
                            <a14:foregroundMark x1="68724" y1="66165" x2="68724" y2="66165"/>
                          </a14:backgroundRemoval>
                        </a14:imgEffect>
                      </a14:imgLayer>
                    </a14:imgProps>
                  </a:ext>
                </a:extLst>
              </a:blip>
              <a:srcRect l="67957" t="58701" r="21721" b="28948"/>
              <a:stretch>
                <a:fillRect/>
              </a:stretch>
            </p:blipFill>
            <p:spPr>
              <a:xfrm rot="10800000">
                <a:off x="5772742" y="3374179"/>
                <a:ext cx="1061886" cy="847062"/>
              </a:xfrm>
              <a:prstGeom prst="rect">
                <a:avLst/>
              </a:prstGeom>
            </p:spPr>
          </p:pic>
          <p:pic>
            <p:nvPicPr>
              <p:cNvPr id="63" name="Imagen 62">
                <a:extLst>
                  <a:ext uri="{FF2B5EF4-FFF2-40B4-BE49-F238E27FC236}">
                    <a16:creationId xmlns:a16="http://schemas.microsoft.com/office/drawing/2014/main" id="{614A9278-8B41-F03F-C401-DE459CFAF9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5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ackgroundRemoval t="62269" b="71181" l="82665" r="91821">
                            <a14:foregroundMark x1="89017" y1="71181" x2="89017" y2="71181"/>
                            <a14:foregroundMark x1="91821" y1="68596" x2="91821" y2="68596"/>
                            <a14:foregroundMark x1="85751" y1="62269" x2="85751" y2="62269"/>
                            <a14:foregroundMark x1="82665" y1="68981" x2="82665" y2="68981"/>
                          </a14:backgroundRemoval>
                        </a14:imgEffect>
                      </a14:imgLayer>
                    </a14:imgProps>
                  </a:ext>
                </a:extLst>
              </a:blip>
              <a:srcRect l="81923" t="61290" r="7610" b="28387"/>
              <a:stretch>
                <a:fillRect/>
              </a:stretch>
            </p:blipFill>
            <p:spPr>
              <a:xfrm rot="10800000">
                <a:off x="7120312" y="3462292"/>
                <a:ext cx="1076633" cy="707922"/>
              </a:xfrm>
              <a:prstGeom prst="rect">
                <a:avLst/>
              </a:prstGeom>
            </p:spPr>
          </p:pic>
        </p:grp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BCDD9A0D-B2A6-F750-F55B-440C4FCF4E06}"/>
                </a:ext>
              </a:extLst>
            </p:cNvPr>
            <p:cNvSpPr txBox="1"/>
            <p:nvPr/>
          </p:nvSpPr>
          <p:spPr>
            <a:xfrm>
              <a:off x="1871626" y="3317958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1400" dirty="0">
                  <a:solidFill>
                    <a:schemeClr val="bg1"/>
                  </a:solidFill>
                </a:rPr>
                <a:t>N15 × IX13 × N8</a:t>
              </a:r>
            </a:p>
            <a:p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5C5705F1-A481-92E4-65B9-AE23F123CE0F}"/>
                </a:ext>
              </a:extLst>
            </p:cNvPr>
            <p:cNvSpPr txBox="1"/>
            <p:nvPr/>
          </p:nvSpPr>
          <p:spPr>
            <a:xfrm>
              <a:off x="1871626" y="2282265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1400" dirty="0">
                  <a:solidFill>
                    <a:schemeClr val="bg1"/>
                  </a:solidFill>
                </a:rPr>
                <a:t>N15 × IX13 × N5</a:t>
              </a:r>
            </a:p>
            <a:p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9DBB5F94-E26A-D5F9-2237-7D09ED618EAE}"/>
                </a:ext>
              </a:extLst>
            </p:cNvPr>
            <p:cNvSpPr txBox="1"/>
            <p:nvPr/>
          </p:nvSpPr>
          <p:spPr>
            <a:xfrm>
              <a:off x="1896717" y="4210124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1400" dirty="0">
                  <a:solidFill>
                    <a:schemeClr val="bg1"/>
                  </a:solidFill>
                </a:rPr>
                <a:t>N5 × IX7 × N8</a:t>
              </a:r>
            </a:p>
            <a:p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4EC645C5-5504-8A90-D781-67F6FA27C852}"/>
                </a:ext>
              </a:extLst>
            </p:cNvPr>
            <p:cNvSpPr txBox="1"/>
            <p:nvPr/>
          </p:nvSpPr>
          <p:spPr>
            <a:xfrm>
              <a:off x="1847192" y="5153942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1400" dirty="0">
                  <a:solidFill>
                    <a:schemeClr val="bg1"/>
                  </a:solidFill>
                </a:rPr>
                <a:t>N5 × IX7 × N14</a:t>
              </a:r>
            </a:p>
            <a:p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09CBAE36-7A44-4AC7-5256-0DE1881F035F}"/>
                </a:ext>
              </a:extLst>
            </p:cNvPr>
            <p:cNvSpPr txBox="1"/>
            <p:nvPr/>
          </p:nvSpPr>
          <p:spPr>
            <a:xfrm>
              <a:off x="1871626" y="864162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b="1" noProof="0">
                  <a:solidFill>
                    <a:schemeClr val="bg1"/>
                  </a:solidFill>
                </a:rPr>
                <a:t>Parental lines</a:t>
              </a:r>
            </a:p>
            <a:p>
              <a:pPr algn="ctr"/>
              <a:endParaRPr lang="en-AU" sz="1400" noProof="0" dirty="0">
                <a:solidFill>
                  <a:schemeClr val="bg1"/>
                </a:solidFill>
              </a:endParaRPr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C82120A7-EFB5-EF60-3E67-8BF657CFC7E8}"/>
                </a:ext>
              </a:extLst>
            </p:cNvPr>
            <p:cNvSpPr txBox="1"/>
            <p:nvPr/>
          </p:nvSpPr>
          <p:spPr>
            <a:xfrm>
              <a:off x="3606334" y="1411743"/>
              <a:ext cx="708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dirty="0">
                  <a:solidFill>
                    <a:schemeClr val="bg1"/>
                  </a:solidFill>
                </a:rPr>
                <a:t>N5</a:t>
              </a:r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8B1318D7-4438-F432-06BC-658CB6AD308D}"/>
                </a:ext>
              </a:extLst>
            </p:cNvPr>
            <p:cNvSpPr txBox="1"/>
            <p:nvPr/>
          </p:nvSpPr>
          <p:spPr>
            <a:xfrm>
              <a:off x="4683564" y="1385428"/>
              <a:ext cx="708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dirty="0">
                  <a:solidFill>
                    <a:schemeClr val="bg1"/>
                  </a:solidFill>
                </a:rPr>
                <a:t>N8</a:t>
              </a:r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EB3D9981-F510-CB23-5B93-7AB5761EF3FD}"/>
                </a:ext>
              </a:extLst>
            </p:cNvPr>
            <p:cNvSpPr txBox="1"/>
            <p:nvPr/>
          </p:nvSpPr>
          <p:spPr>
            <a:xfrm>
              <a:off x="5729001" y="1386998"/>
              <a:ext cx="708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dirty="0">
                  <a:solidFill>
                    <a:schemeClr val="bg1"/>
                  </a:solidFill>
                </a:rPr>
                <a:t>N14</a:t>
              </a:r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1F93540B-6B43-D74B-3AC0-22134F56BD66}"/>
                </a:ext>
              </a:extLst>
            </p:cNvPr>
            <p:cNvSpPr txBox="1"/>
            <p:nvPr/>
          </p:nvSpPr>
          <p:spPr>
            <a:xfrm>
              <a:off x="6864083" y="1400459"/>
              <a:ext cx="708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dirty="0">
                  <a:solidFill>
                    <a:schemeClr val="bg1"/>
                  </a:solidFill>
                </a:rPr>
                <a:t>N15</a:t>
              </a:r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5" name="Cerrar llave 74">
              <a:extLst>
                <a:ext uri="{FF2B5EF4-FFF2-40B4-BE49-F238E27FC236}">
                  <a16:creationId xmlns:a16="http://schemas.microsoft.com/office/drawing/2014/main" id="{7AAD54C6-0F97-12A4-68A2-33344D4CB535}"/>
                </a:ext>
              </a:extLst>
            </p:cNvPr>
            <p:cNvSpPr/>
            <p:nvPr/>
          </p:nvSpPr>
          <p:spPr>
            <a:xfrm rot="16200000">
              <a:off x="5501949" y="-1411559"/>
              <a:ext cx="210196" cy="4144290"/>
            </a:xfrm>
            <a:prstGeom prst="rightBrace">
              <a:avLst/>
            </a:prstGeom>
            <a:ln w="127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6" name="Cerrar llave 75">
              <a:extLst>
                <a:ext uri="{FF2B5EF4-FFF2-40B4-BE49-F238E27FC236}">
                  <a16:creationId xmlns:a16="http://schemas.microsoft.com/office/drawing/2014/main" id="{57200F7E-0CDD-68A1-239E-652E0106D8A4}"/>
                </a:ext>
              </a:extLst>
            </p:cNvPr>
            <p:cNvSpPr/>
            <p:nvPr/>
          </p:nvSpPr>
          <p:spPr>
            <a:xfrm rot="16200000">
              <a:off x="9688669" y="-254916"/>
              <a:ext cx="225701" cy="1859389"/>
            </a:xfrm>
            <a:prstGeom prst="rightBrace">
              <a:avLst/>
            </a:prstGeom>
            <a:ln w="127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A9215D6A-FF8E-6847-E218-6D84754CF329}"/>
                </a:ext>
              </a:extLst>
            </p:cNvPr>
            <p:cNvSpPr txBox="1"/>
            <p:nvPr/>
          </p:nvSpPr>
          <p:spPr>
            <a:xfrm>
              <a:off x="272091" y="3694082"/>
              <a:ext cx="1600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400" dirty="0">
                  <a:solidFill>
                    <a:schemeClr val="bg1"/>
                  </a:solidFill>
                </a:rPr>
                <a:t>BC</a:t>
              </a:r>
              <a:r>
                <a:rPr lang="es-CL" sz="1400" baseline="-25000" dirty="0">
                  <a:solidFill>
                    <a:schemeClr val="bg1"/>
                  </a:solidFill>
                </a:rPr>
                <a:t>1</a:t>
              </a:r>
              <a:r>
                <a:rPr lang="es-CL" sz="1400" dirty="0">
                  <a:solidFill>
                    <a:schemeClr val="bg1"/>
                  </a:solidFill>
                </a:rPr>
                <a:t>F</a:t>
              </a:r>
              <a:r>
                <a:rPr lang="es-CL" sz="1400" baseline="-25000" dirty="0">
                  <a:solidFill>
                    <a:schemeClr val="bg1"/>
                  </a:solidFill>
                </a:rPr>
                <a:t>1</a:t>
              </a:r>
            </a:p>
            <a:p>
              <a:endParaRPr lang="es-ES" sz="1400" dirty="0">
                <a:solidFill>
                  <a:schemeClr val="bg1"/>
                </a:solidFill>
              </a:endParaRPr>
            </a:p>
          </p:txBody>
        </p:sp>
        <p:sp>
          <p:nvSpPr>
            <p:cNvPr id="78" name="Cerrar llave 77">
              <a:extLst>
                <a:ext uri="{FF2B5EF4-FFF2-40B4-BE49-F238E27FC236}">
                  <a16:creationId xmlns:a16="http://schemas.microsoft.com/office/drawing/2014/main" id="{71F44FEB-A474-5CA2-2120-F05BD811FB36}"/>
                </a:ext>
              </a:extLst>
            </p:cNvPr>
            <p:cNvSpPr/>
            <p:nvPr/>
          </p:nvSpPr>
          <p:spPr>
            <a:xfrm rot="10800000">
              <a:off x="1506750" y="1777423"/>
              <a:ext cx="301077" cy="3992997"/>
            </a:xfrm>
            <a:prstGeom prst="rightBrace">
              <a:avLst>
                <a:gd name="adj1" fmla="val 8333"/>
                <a:gd name="adj2" fmla="val 47881"/>
              </a:avLst>
            </a:prstGeom>
            <a:ln w="127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6792860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80</Words>
  <Application>Microsoft Office PowerPoint</Application>
  <PresentationFormat>Panorámica</PresentationFormat>
  <Paragraphs>1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ula Andrea Vásquez Teuber</dc:creator>
  <cp:lastModifiedBy>Paula Andrea Vásquez Teuber</cp:lastModifiedBy>
  <cp:revision>5</cp:revision>
  <dcterms:created xsi:type="dcterms:W3CDTF">2025-12-04T12:04:39Z</dcterms:created>
  <dcterms:modified xsi:type="dcterms:W3CDTF">2025-12-18T13:18:37Z</dcterms:modified>
</cp:coreProperties>
</file>